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56" r:id="rId2"/>
    <p:sldId id="261" r:id="rId3"/>
    <p:sldId id="259" r:id="rId4"/>
    <p:sldId id="262" r:id="rId5"/>
    <p:sldId id="260" r:id="rId6"/>
    <p:sldId id="263" r:id="rId7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Windows User" initials="WU" lastIdx="1" clrIdx="0">
    <p:extLst>
      <p:ext uri="{19B8F6BF-5375-455C-9EA6-DF929625EA0E}">
        <p15:presenceInfo xmlns:p15="http://schemas.microsoft.com/office/powerpoint/2012/main" userId="ccae270cf01d69fb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7" autoAdjust="0"/>
    <p:restoredTop sz="90135" autoAdjust="0"/>
  </p:normalViewPr>
  <p:slideViewPr>
    <p:cSldViewPr snapToGrid="0">
      <p:cViewPr varScale="1">
        <p:scale>
          <a:sx n="74" d="100"/>
          <a:sy n="74" d="100"/>
        </p:scale>
        <p:origin x="967" y="3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_tradnl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10250D4-EDAD-4BCE-8D04-4A6DD589326C}" type="datetimeFigureOut">
              <a:rPr lang="es-ES_tradnl" smtClean="0"/>
              <a:t>20/05/2024</a:t>
            </a:fld>
            <a:endParaRPr lang="es-ES_tradnl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_tradnl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S_tradn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_tradn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6B62A4-2159-432D-8411-03F477F8CE32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3693722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_tradnl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D6B62A4-2159-432D-8411-03F477F8CE32}" type="slidenum">
              <a:rPr lang="es-ES_tradnl" smtClean="0"/>
              <a:t>1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281131458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_tradnl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D6B62A4-2159-432D-8411-03F477F8CE32}" type="slidenum">
              <a:rPr lang="es-ES_tradnl" smtClean="0"/>
              <a:t>2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79446249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C3E4914-78AA-4A04-87F4-0AE7D679154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ES_tradnl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3B6B8D36-9CB5-49D8-AA78-A1EB74128BB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s-ES_tradn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822BE74-3389-4580-A68F-4C9DC84E3B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1823D-F14F-41EA-9C1B-6F2EEFF5788D}" type="datetimeFigureOut">
              <a:rPr lang="es-ES_tradnl" smtClean="0"/>
              <a:t>20/05/2024</a:t>
            </a:fld>
            <a:endParaRPr lang="es-ES_tradn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3AD66FB9-C404-4C58-A22E-EE1D5B7350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8B0B9AF6-636D-4963-99B9-81FE0CCF7B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57839-F978-410F-9854-E9D913D4F478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958643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98925AC-6D7E-40A2-836A-2112999C55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8FE3F3F3-3D7C-4516-93B3-EC2CDCE4155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S_tradn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D219FBC1-776A-470C-8101-74CE2833B8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1823D-F14F-41EA-9C1B-6F2EEFF5788D}" type="datetimeFigureOut">
              <a:rPr lang="es-ES_tradnl" smtClean="0"/>
              <a:t>20/05/2024</a:t>
            </a:fld>
            <a:endParaRPr lang="es-ES_tradn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DC762ADF-CE85-40DD-8113-CAEFF26303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13723945-1F93-4E88-83E0-10113ED07A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57839-F978-410F-9854-E9D913D4F478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8513008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63B1C02F-40A9-4C70-8902-1A9DFE17631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A08BE10E-9C14-41CF-8C5A-A837C9197A9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S_tradn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E1029DC-E57A-4AF3-ACC1-748AA00E67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1823D-F14F-41EA-9C1B-6F2EEFF5788D}" type="datetimeFigureOut">
              <a:rPr lang="es-ES_tradnl" smtClean="0"/>
              <a:t>20/05/2024</a:t>
            </a:fld>
            <a:endParaRPr lang="es-ES_tradn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365E3E8-5A5C-4A6C-BFFC-BDE6A96096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899F5CF0-FFCF-4EB7-8EA8-088F833A74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57839-F978-410F-9854-E9D913D4F478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7959908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12C178A-C4BB-4B84-9FF9-406DD43454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D7E64D9E-85E9-45B0-BF39-732800633AD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S_tradn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A547E5E9-FBBB-4EF4-BC36-0DABCF61AC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1823D-F14F-41EA-9C1B-6F2EEFF5788D}" type="datetimeFigureOut">
              <a:rPr lang="es-ES_tradnl" smtClean="0"/>
              <a:t>20/05/2024</a:t>
            </a:fld>
            <a:endParaRPr lang="es-ES_tradn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8110F1F-0E59-4EB9-B041-F96CBA2402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83AC83E-C3B3-439B-843C-78D5CC18F6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57839-F978-410F-9854-E9D913D4F478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40333558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1030604-55C0-404E-9F00-937192D026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773C6E09-E6D9-405F-BC4F-01993FB451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4AA87031-46E9-410B-A405-DE5D7EE7DD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1823D-F14F-41EA-9C1B-6F2EEFF5788D}" type="datetimeFigureOut">
              <a:rPr lang="es-ES_tradnl" smtClean="0"/>
              <a:t>20/05/2024</a:t>
            </a:fld>
            <a:endParaRPr lang="es-ES_tradn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0C667D5-DC4F-4F88-9F42-562A983896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0AFC128-A99F-4C2D-A4C1-B03E2496E6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57839-F978-410F-9854-E9D913D4F478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24999775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E143994-D16B-423E-BE0B-98E674C1E2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941C6F69-3137-4506-A792-69F66DB2D71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S_tradnl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5350CDDC-EA93-4023-891C-E2CAF4E82AD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S_tradnl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DD388DC8-AD8B-4EB8-8AB1-48B13A5E5E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1823D-F14F-41EA-9C1B-6F2EEFF5788D}" type="datetimeFigureOut">
              <a:rPr lang="es-ES_tradnl" smtClean="0"/>
              <a:t>20/05/2024</a:t>
            </a:fld>
            <a:endParaRPr lang="es-ES_tradnl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CBBCC5EE-60BD-4ADA-A7A8-493AD923D0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61240FEB-E36E-481F-86E0-C9761E8AC3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57839-F978-410F-9854-E9D913D4F478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21104279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813EB93-6B91-4D38-A193-9791661D97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404EE65B-232D-49EA-8306-A4D0F99A00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44EB5AB4-B883-4E19-B6E6-21F97326CF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S_tradnl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8B5BD175-608E-439B-97B2-5B31BA672BC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291244DA-64ED-430C-912F-153C32AC90B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S_tradnl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F0B2B7F0-F2C0-47DF-A92B-E9004036CB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1823D-F14F-41EA-9C1B-6F2EEFF5788D}" type="datetimeFigureOut">
              <a:rPr lang="es-ES_tradnl" smtClean="0"/>
              <a:t>20/05/2024</a:t>
            </a:fld>
            <a:endParaRPr lang="es-ES_tradnl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21C59E1C-5BEA-4DEB-A397-920754E936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1C50270F-FF52-4751-A2AF-E5CDDEE847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57839-F978-410F-9854-E9D913D4F478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24843949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96A63D7-8EBE-4B90-AA55-E8E5673946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C71C9475-CCF3-4B62-A678-045A345704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1823D-F14F-41EA-9C1B-6F2EEFF5788D}" type="datetimeFigureOut">
              <a:rPr lang="es-ES_tradnl" smtClean="0"/>
              <a:t>20/05/2024</a:t>
            </a:fld>
            <a:endParaRPr lang="es-ES_tradnl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49D96A20-B826-4016-A341-0B5F4EA92C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46864EE0-7DF8-46FF-8F6F-5C07E1E464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57839-F978-410F-9854-E9D913D4F478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23508522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BCBFF731-69E4-4DE4-A429-1DE563B752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1823D-F14F-41EA-9C1B-6F2EEFF5788D}" type="datetimeFigureOut">
              <a:rPr lang="es-ES_tradnl" smtClean="0"/>
              <a:t>20/05/2024</a:t>
            </a:fld>
            <a:endParaRPr lang="es-ES_tradnl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23CA0656-7580-4F7D-9FAE-C7BCF4D4D0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F8353760-50D5-40CF-832C-BB645CCCC0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57839-F978-410F-9854-E9D913D4F478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27197498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BC2DE30-E2DD-4F0A-92B6-39FE78C266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B4068343-0F82-4656-A0B2-42CE7B3C69B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S_tradnl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97B682A6-3AFA-4CF9-8A38-F65B4F9024A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13876872-EB30-4CBC-AAB5-0DE8D16849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1823D-F14F-41EA-9C1B-6F2EEFF5788D}" type="datetimeFigureOut">
              <a:rPr lang="es-ES_tradnl" smtClean="0"/>
              <a:t>20/05/2024</a:t>
            </a:fld>
            <a:endParaRPr lang="es-ES_tradnl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718EBB06-3A3D-41CC-9210-98AFB42D57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8B6FD056-E10A-4BCE-BB13-029104962B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57839-F978-410F-9854-E9D913D4F478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21059550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F129E17-B372-45F7-A4AF-5E6F887C06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DC10BC79-4909-485D-BE08-952988283DE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_tradnl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E806F9E2-C349-4DE6-A0FA-4169406E92C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A7EE29A2-60D5-4393-9867-E4AA604FC0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1823D-F14F-41EA-9C1B-6F2EEFF5788D}" type="datetimeFigureOut">
              <a:rPr lang="es-ES_tradnl" smtClean="0"/>
              <a:t>20/05/2024</a:t>
            </a:fld>
            <a:endParaRPr lang="es-ES_tradnl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86D23851-961E-4594-8527-0998448E55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29486B52-E684-4067-810B-5EB330447D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57839-F978-410F-9854-E9D913D4F478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37185919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78E80821-124B-4404-B334-03893DB375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2C08CB28-769C-429D-86E4-485DEF410C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S_tradn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E5A42A4F-316D-445F-879D-18B47EDC3B6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01823D-F14F-41EA-9C1B-6F2EEFF5788D}" type="datetimeFigureOut">
              <a:rPr lang="es-ES_tradnl" smtClean="0"/>
              <a:t>20/05/2024</a:t>
            </a:fld>
            <a:endParaRPr lang="es-ES_tradn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F62F7703-3105-406C-B6D5-969DF17CBC6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_tradn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776FE2E-A4EE-4D10-918A-7297E112DC3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857839-F978-410F-9854-E9D913D4F478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33644281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uadroTexto 7">
            <a:extLst>
              <a:ext uri="{FF2B5EF4-FFF2-40B4-BE49-F238E27FC236}">
                <a16:creationId xmlns:a16="http://schemas.microsoft.com/office/drawing/2014/main" id="{6C66FDA2-E512-44BA-B4AC-29172E1E3A9B}"/>
              </a:ext>
            </a:extLst>
          </p:cNvPr>
          <p:cNvSpPr txBox="1"/>
          <p:nvPr/>
        </p:nvSpPr>
        <p:spPr>
          <a:xfrm>
            <a:off x="1780576" y="1026367"/>
            <a:ext cx="26064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b="1" dirty="0"/>
              <a:t>a) GSE36389 GEO </a:t>
            </a:r>
            <a:r>
              <a:rPr lang="es-ES_tradnl" b="1" dirty="0" err="1"/>
              <a:t>dataset</a:t>
            </a:r>
            <a:endParaRPr lang="es-ES_tradnl" b="1" dirty="0"/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9A524518-BEF5-4D0A-A52D-276C3B94F293}"/>
              </a:ext>
            </a:extLst>
          </p:cNvPr>
          <p:cNvSpPr txBox="1"/>
          <p:nvPr/>
        </p:nvSpPr>
        <p:spPr>
          <a:xfrm>
            <a:off x="4972134" y="370277"/>
            <a:ext cx="224773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2000" b="1" dirty="0"/>
              <a:t>Endometrial </a:t>
            </a:r>
            <a:r>
              <a:rPr lang="es-ES_tradnl" sz="2000" b="1" dirty="0" err="1"/>
              <a:t>cancer</a:t>
            </a:r>
            <a:endParaRPr lang="es-ES_tradnl" sz="2000" b="1" dirty="0"/>
          </a:p>
        </p:txBody>
      </p:sp>
      <p:pic>
        <p:nvPicPr>
          <p:cNvPr id="3" name="Imagen 2">
            <a:extLst>
              <a:ext uri="{FF2B5EF4-FFF2-40B4-BE49-F238E27FC236}">
                <a16:creationId xmlns:a16="http://schemas.microsoft.com/office/drawing/2014/main" id="{E50D6A27-33CD-4008-A2BA-E620FF0F498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650" y="1359833"/>
            <a:ext cx="6409356" cy="4807017"/>
          </a:xfrm>
          <a:prstGeom prst="rect">
            <a:avLst/>
          </a:prstGeom>
        </p:spPr>
      </p:pic>
      <p:pic>
        <p:nvPicPr>
          <p:cNvPr id="7" name="Imagen 6">
            <a:extLst>
              <a:ext uri="{FF2B5EF4-FFF2-40B4-BE49-F238E27FC236}">
                <a16:creationId xmlns:a16="http://schemas.microsoft.com/office/drawing/2014/main" id="{9952231D-ADB5-44E9-88AD-BFEDDC01759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93294" y="1762801"/>
            <a:ext cx="4787849" cy="398987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" name="CuadroTexto 1">
            <a:extLst>
              <a:ext uri="{FF2B5EF4-FFF2-40B4-BE49-F238E27FC236}">
                <a16:creationId xmlns:a16="http://schemas.microsoft.com/office/drawing/2014/main" id="{208E4A9E-77F2-4076-9F3F-FE3BE9F3082D}"/>
              </a:ext>
            </a:extLst>
          </p:cNvPr>
          <p:cNvSpPr txBox="1"/>
          <p:nvPr/>
        </p:nvSpPr>
        <p:spPr>
          <a:xfrm>
            <a:off x="86639" y="6270170"/>
            <a:ext cx="1169450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_tradnl" sz="1400" dirty="0"/>
              <a:t>Principal </a:t>
            </a:r>
            <a:r>
              <a:rPr lang="es-ES_tradnl" sz="1400" dirty="0" err="1"/>
              <a:t>Component</a:t>
            </a:r>
            <a:r>
              <a:rPr lang="es-ES_tradnl" sz="1400" dirty="0"/>
              <a:t> </a:t>
            </a:r>
            <a:r>
              <a:rPr lang="es-ES_tradnl" sz="1400" dirty="0" err="1"/>
              <a:t>Analysis</a:t>
            </a:r>
            <a:r>
              <a:rPr lang="es-ES_tradnl" sz="1400" dirty="0"/>
              <a:t> (PCA) </a:t>
            </a:r>
            <a:r>
              <a:rPr lang="en-US" sz="1400" dirty="0"/>
              <a:t>plots of the whole set of genes in the dataset (left) </a:t>
            </a:r>
            <a:r>
              <a:rPr lang="en-US" sz="1400" i="1" dirty="0"/>
              <a:t>vs</a:t>
            </a:r>
            <a:r>
              <a:rPr lang="en-US" sz="1400" dirty="0"/>
              <a:t>. differentially expressed genes after Comparative Analysis of Shapley value analysis (p-value &lt; 0.01) (right).</a:t>
            </a:r>
            <a:r>
              <a:rPr lang="es-ES_tradnl" sz="1400" dirty="0"/>
              <a:t> </a:t>
            </a:r>
          </a:p>
        </p:txBody>
      </p:sp>
      <p:sp>
        <p:nvSpPr>
          <p:cNvPr id="4" name="Rectángulo 3">
            <a:extLst>
              <a:ext uri="{FF2B5EF4-FFF2-40B4-BE49-F238E27FC236}">
                <a16:creationId xmlns:a16="http://schemas.microsoft.com/office/drawing/2014/main" id="{846F2797-9136-4B04-99E5-FB6415AEDFCC}"/>
              </a:ext>
            </a:extLst>
          </p:cNvPr>
          <p:cNvSpPr/>
          <p:nvPr/>
        </p:nvSpPr>
        <p:spPr>
          <a:xfrm>
            <a:off x="2531390" y="1462009"/>
            <a:ext cx="1090047" cy="24454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24144116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uadroTexto 7">
            <a:extLst>
              <a:ext uri="{FF2B5EF4-FFF2-40B4-BE49-F238E27FC236}">
                <a16:creationId xmlns:a16="http://schemas.microsoft.com/office/drawing/2014/main" id="{6C66FDA2-E512-44BA-B4AC-29172E1E3A9B}"/>
              </a:ext>
            </a:extLst>
          </p:cNvPr>
          <p:cNvSpPr txBox="1"/>
          <p:nvPr/>
        </p:nvSpPr>
        <p:spPr>
          <a:xfrm>
            <a:off x="1780576" y="1026367"/>
            <a:ext cx="26161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b="1" dirty="0"/>
              <a:t>b) GSE63678 GEO </a:t>
            </a:r>
            <a:r>
              <a:rPr lang="es-ES_tradnl" b="1" dirty="0" err="1"/>
              <a:t>dataset</a:t>
            </a:r>
            <a:endParaRPr lang="es-ES_tradnl" b="1" dirty="0"/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9A524518-BEF5-4D0A-A52D-276C3B94F293}"/>
              </a:ext>
            </a:extLst>
          </p:cNvPr>
          <p:cNvSpPr txBox="1"/>
          <p:nvPr/>
        </p:nvSpPr>
        <p:spPr>
          <a:xfrm>
            <a:off x="4972134" y="370277"/>
            <a:ext cx="224773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2000" b="1" dirty="0"/>
              <a:t>Endometrial </a:t>
            </a:r>
            <a:r>
              <a:rPr lang="es-ES_tradnl" sz="2000" b="1" dirty="0" err="1"/>
              <a:t>cancer</a:t>
            </a:r>
            <a:endParaRPr lang="es-ES_tradnl" sz="2000" b="1" dirty="0"/>
          </a:p>
        </p:txBody>
      </p:sp>
      <p:pic>
        <p:nvPicPr>
          <p:cNvPr id="6" name="Imagen 5">
            <a:extLst>
              <a:ext uri="{FF2B5EF4-FFF2-40B4-BE49-F238E27FC236}">
                <a16:creationId xmlns:a16="http://schemas.microsoft.com/office/drawing/2014/main" id="{2B29CEED-DB99-43DC-A9E9-53DBE625DA6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646" y="1395772"/>
            <a:ext cx="6249178" cy="4686884"/>
          </a:xfrm>
          <a:prstGeom prst="rect">
            <a:avLst/>
          </a:prstGeom>
        </p:spPr>
      </p:pic>
      <p:pic>
        <p:nvPicPr>
          <p:cNvPr id="7" name="Imagen 6">
            <a:extLst>
              <a:ext uri="{FF2B5EF4-FFF2-40B4-BE49-F238E27FC236}">
                <a16:creationId xmlns:a16="http://schemas.microsoft.com/office/drawing/2014/main" id="{E3C460B4-4341-4AF9-9A8D-F651D5A43B6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22098" y="1491962"/>
            <a:ext cx="5393404" cy="449450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CuadroTexto 8">
            <a:extLst>
              <a:ext uri="{FF2B5EF4-FFF2-40B4-BE49-F238E27FC236}">
                <a16:creationId xmlns:a16="http://schemas.microsoft.com/office/drawing/2014/main" id="{3C22473F-C13E-4EBD-AAA8-90DF6EE2A1AC}"/>
              </a:ext>
            </a:extLst>
          </p:cNvPr>
          <p:cNvSpPr txBox="1"/>
          <p:nvPr/>
        </p:nvSpPr>
        <p:spPr>
          <a:xfrm>
            <a:off x="86639" y="6270170"/>
            <a:ext cx="1169450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_tradnl" sz="1400" dirty="0"/>
              <a:t>Principal </a:t>
            </a:r>
            <a:r>
              <a:rPr lang="es-ES_tradnl" sz="1400" dirty="0" err="1"/>
              <a:t>Component</a:t>
            </a:r>
            <a:r>
              <a:rPr lang="es-ES_tradnl" sz="1400" dirty="0"/>
              <a:t> </a:t>
            </a:r>
            <a:r>
              <a:rPr lang="es-ES_tradnl" sz="1400" dirty="0" err="1"/>
              <a:t>Analysis</a:t>
            </a:r>
            <a:r>
              <a:rPr lang="es-ES_tradnl" sz="1400" dirty="0"/>
              <a:t> (PCA) </a:t>
            </a:r>
            <a:r>
              <a:rPr lang="en-US" sz="1400" dirty="0"/>
              <a:t>plots of the whole set of genes in the dataset (left) </a:t>
            </a:r>
            <a:r>
              <a:rPr lang="en-US" sz="1400" i="1" dirty="0"/>
              <a:t>vs</a:t>
            </a:r>
            <a:r>
              <a:rPr lang="en-US" sz="1400" dirty="0"/>
              <a:t>. differentially expressed genes after Comparative Analysis of Shapley value analysis (p-value &lt; 0.01) (right).</a:t>
            </a:r>
            <a:r>
              <a:rPr lang="es-ES_tradnl" sz="1400" dirty="0"/>
              <a:t> </a:t>
            </a:r>
          </a:p>
        </p:txBody>
      </p:sp>
      <p:sp>
        <p:nvSpPr>
          <p:cNvPr id="10" name="Rectángulo 9">
            <a:extLst>
              <a:ext uri="{FF2B5EF4-FFF2-40B4-BE49-F238E27FC236}">
                <a16:creationId xmlns:a16="http://schemas.microsoft.com/office/drawing/2014/main" id="{96BB71A9-A7CC-4D4A-B8E0-96BADD4CB71A}"/>
              </a:ext>
            </a:extLst>
          </p:cNvPr>
          <p:cNvSpPr/>
          <p:nvPr/>
        </p:nvSpPr>
        <p:spPr>
          <a:xfrm>
            <a:off x="2531390" y="1462009"/>
            <a:ext cx="1090047" cy="24454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79113676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uadroTexto 7">
            <a:extLst>
              <a:ext uri="{FF2B5EF4-FFF2-40B4-BE49-F238E27FC236}">
                <a16:creationId xmlns:a16="http://schemas.microsoft.com/office/drawing/2014/main" id="{6C66FDA2-E512-44BA-B4AC-29172E1E3A9B}"/>
              </a:ext>
            </a:extLst>
          </p:cNvPr>
          <p:cNvSpPr txBox="1"/>
          <p:nvPr/>
        </p:nvSpPr>
        <p:spPr>
          <a:xfrm>
            <a:off x="1823953" y="1026367"/>
            <a:ext cx="24718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b="1" dirty="0"/>
              <a:t>c) GSE7846 GEO </a:t>
            </a:r>
            <a:r>
              <a:rPr lang="es-ES_tradnl" b="1" dirty="0" err="1"/>
              <a:t>dataset</a:t>
            </a:r>
            <a:endParaRPr lang="es-ES_tradnl" b="1" dirty="0"/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9A524518-BEF5-4D0A-A52D-276C3B94F293}"/>
              </a:ext>
            </a:extLst>
          </p:cNvPr>
          <p:cNvSpPr txBox="1"/>
          <p:nvPr/>
        </p:nvSpPr>
        <p:spPr>
          <a:xfrm>
            <a:off x="5242723" y="370277"/>
            <a:ext cx="170739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2000" b="1" dirty="0"/>
              <a:t>Endometriosis</a:t>
            </a:r>
          </a:p>
        </p:txBody>
      </p:sp>
      <p:pic>
        <p:nvPicPr>
          <p:cNvPr id="4" name="Imagen 3">
            <a:extLst>
              <a:ext uri="{FF2B5EF4-FFF2-40B4-BE49-F238E27FC236}">
                <a16:creationId xmlns:a16="http://schemas.microsoft.com/office/drawing/2014/main" id="{F588DA8F-7191-4922-AD9D-59D9751F13C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7665" y="1437863"/>
            <a:ext cx="6280857" cy="4414545"/>
          </a:xfrm>
          <a:prstGeom prst="rect">
            <a:avLst/>
          </a:prstGeom>
        </p:spPr>
      </p:pic>
      <p:pic>
        <p:nvPicPr>
          <p:cNvPr id="9" name="Imagen 8">
            <a:extLst>
              <a:ext uri="{FF2B5EF4-FFF2-40B4-BE49-F238E27FC236}">
                <a16:creationId xmlns:a16="http://schemas.microsoft.com/office/drawing/2014/main" id="{87E3637D-A760-49DA-B6D8-0B508818369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44003" y="1794761"/>
            <a:ext cx="4716625" cy="393052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CuadroTexto 5">
            <a:extLst>
              <a:ext uri="{FF2B5EF4-FFF2-40B4-BE49-F238E27FC236}">
                <a16:creationId xmlns:a16="http://schemas.microsoft.com/office/drawing/2014/main" id="{849A7778-86DC-4EEC-B01B-4A0612CFF30F}"/>
              </a:ext>
            </a:extLst>
          </p:cNvPr>
          <p:cNvSpPr txBox="1"/>
          <p:nvPr/>
        </p:nvSpPr>
        <p:spPr>
          <a:xfrm>
            <a:off x="86639" y="6270170"/>
            <a:ext cx="1169450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_tradnl" sz="1400" dirty="0"/>
              <a:t>Principal </a:t>
            </a:r>
            <a:r>
              <a:rPr lang="es-ES_tradnl" sz="1400" dirty="0" err="1"/>
              <a:t>Component</a:t>
            </a:r>
            <a:r>
              <a:rPr lang="es-ES_tradnl" sz="1400" dirty="0"/>
              <a:t> </a:t>
            </a:r>
            <a:r>
              <a:rPr lang="es-ES_tradnl" sz="1400" dirty="0" err="1"/>
              <a:t>Analysis</a:t>
            </a:r>
            <a:r>
              <a:rPr lang="es-ES_tradnl" sz="1400" dirty="0"/>
              <a:t> (PCA) </a:t>
            </a:r>
            <a:r>
              <a:rPr lang="en-US" sz="1400" dirty="0"/>
              <a:t>plots of the whole set of genes in the dataset (left) </a:t>
            </a:r>
            <a:r>
              <a:rPr lang="en-US" sz="1400" i="1" dirty="0"/>
              <a:t>vs</a:t>
            </a:r>
            <a:r>
              <a:rPr lang="en-US" sz="1400" dirty="0"/>
              <a:t>. differentially expressed genes after Comparative Analysis of Shapley value analysis (p-value &lt; 0.01) (right).</a:t>
            </a:r>
            <a:r>
              <a:rPr lang="es-ES_tradnl" sz="1400" dirty="0"/>
              <a:t> </a:t>
            </a:r>
          </a:p>
        </p:txBody>
      </p:sp>
      <p:sp>
        <p:nvSpPr>
          <p:cNvPr id="7" name="Rectángulo 6">
            <a:extLst>
              <a:ext uri="{FF2B5EF4-FFF2-40B4-BE49-F238E27FC236}">
                <a16:creationId xmlns:a16="http://schemas.microsoft.com/office/drawing/2014/main" id="{55903736-FDAA-485A-BA2A-166B0AAAB632}"/>
              </a:ext>
            </a:extLst>
          </p:cNvPr>
          <p:cNvSpPr/>
          <p:nvPr/>
        </p:nvSpPr>
        <p:spPr>
          <a:xfrm>
            <a:off x="2531390" y="1462009"/>
            <a:ext cx="1090047" cy="24454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281928379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uadroTexto 7">
            <a:extLst>
              <a:ext uri="{FF2B5EF4-FFF2-40B4-BE49-F238E27FC236}">
                <a16:creationId xmlns:a16="http://schemas.microsoft.com/office/drawing/2014/main" id="{6C66FDA2-E512-44BA-B4AC-29172E1E3A9B}"/>
              </a:ext>
            </a:extLst>
          </p:cNvPr>
          <p:cNvSpPr txBox="1"/>
          <p:nvPr/>
        </p:nvSpPr>
        <p:spPr>
          <a:xfrm>
            <a:off x="1823953" y="1026367"/>
            <a:ext cx="26161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b="1" dirty="0"/>
              <a:t>d) GSE17504 GEO </a:t>
            </a:r>
            <a:r>
              <a:rPr lang="es-ES_tradnl" b="1" dirty="0" err="1"/>
              <a:t>dataset</a:t>
            </a:r>
            <a:endParaRPr lang="es-ES_tradnl" b="1" dirty="0"/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9A524518-BEF5-4D0A-A52D-276C3B94F293}"/>
              </a:ext>
            </a:extLst>
          </p:cNvPr>
          <p:cNvSpPr txBox="1"/>
          <p:nvPr/>
        </p:nvSpPr>
        <p:spPr>
          <a:xfrm>
            <a:off x="5242723" y="370277"/>
            <a:ext cx="170739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2000" b="1" dirty="0"/>
              <a:t>Endometriosis</a:t>
            </a:r>
          </a:p>
        </p:txBody>
      </p:sp>
      <p:pic>
        <p:nvPicPr>
          <p:cNvPr id="7" name="Imagen 6">
            <a:extLst>
              <a:ext uri="{FF2B5EF4-FFF2-40B4-BE49-F238E27FC236}">
                <a16:creationId xmlns:a16="http://schemas.microsoft.com/office/drawing/2014/main" id="{855BC745-2B82-48BC-991D-EB981E7B96C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5677" y="1459528"/>
            <a:ext cx="5836296" cy="4377222"/>
          </a:xfrm>
          <a:prstGeom prst="rect">
            <a:avLst/>
          </a:prstGeom>
        </p:spPr>
      </p:pic>
      <p:pic>
        <p:nvPicPr>
          <p:cNvPr id="9" name="Imagen 8">
            <a:extLst>
              <a:ext uri="{FF2B5EF4-FFF2-40B4-BE49-F238E27FC236}">
                <a16:creationId xmlns:a16="http://schemas.microsoft.com/office/drawing/2014/main" id="{730936EE-682F-49A3-A898-E892E37AF8C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76088" y="1382552"/>
            <a:ext cx="5608163" cy="467346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CuadroTexto 5">
            <a:extLst>
              <a:ext uri="{FF2B5EF4-FFF2-40B4-BE49-F238E27FC236}">
                <a16:creationId xmlns:a16="http://schemas.microsoft.com/office/drawing/2014/main" id="{69F3D399-32A0-4EE4-953E-7ED57B3A1418}"/>
              </a:ext>
            </a:extLst>
          </p:cNvPr>
          <p:cNvSpPr txBox="1"/>
          <p:nvPr/>
        </p:nvSpPr>
        <p:spPr>
          <a:xfrm>
            <a:off x="86639" y="6270170"/>
            <a:ext cx="1169450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_tradnl" sz="1400" dirty="0"/>
              <a:t>Principal </a:t>
            </a:r>
            <a:r>
              <a:rPr lang="es-ES_tradnl" sz="1400" dirty="0" err="1"/>
              <a:t>Component</a:t>
            </a:r>
            <a:r>
              <a:rPr lang="es-ES_tradnl" sz="1400" dirty="0"/>
              <a:t> </a:t>
            </a:r>
            <a:r>
              <a:rPr lang="es-ES_tradnl" sz="1400" dirty="0" err="1"/>
              <a:t>Analysis</a:t>
            </a:r>
            <a:r>
              <a:rPr lang="es-ES_tradnl" sz="1400" dirty="0"/>
              <a:t> (PCA) </a:t>
            </a:r>
            <a:r>
              <a:rPr lang="en-US" sz="1400" dirty="0"/>
              <a:t>plots of the whole set of genes in the dataset (left) </a:t>
            </a:r>
            <a:r>
              <a:rPr lang="en-US" sz="1400" i="1" dirty="0"/>
              <a:t>vs</a:t>
            </a:r>
            <a:r>
              <a:rPr lang="en-US" sz="1400" dirty="0"/>
              <a:t>. differentially expressed genes after Comparative Analysis of Shapley value analysis (p-value &lt; 0.01) (right).</a:t>
            </a:r>
            <a:r>
              <a:rPr lang="es-ES_tradnl" sz="1400" dirty="0"/>
              <a:t> </a:t>
            </a:r>
          </a:p>
        </p:txBody>
      </p:sp>
      <p:sp>
        <p:nvSpPr>
          <p:cNvPr id="10" name="Rectángulo 9">
            <a:extLst>
              <a:ext uri="{FF2B5EF4-FFF2-40B4-BE49-F238E27FC236}">
                <a16:creationId xmlns:a16="http://schemas.microsoft.com/office/drawing/2014/main" id="{DD592191-288D-47AA-B89B-509DC3E90BEC}"/>
              </a:ext>
            </a:extLst>
          </p:cNvPr>
          <p:cNvSpPr/>
          <p:nvPr/>
        </p:nvSpPr>
        <p:spPr>
          <a:xfrm>
            <a:off x="2531390" y="1462009"/>
            <a:ext cx="1090047" cy="24454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289005324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uadroTexto 7">
            <a:extLst>
              <a:ext uri="{FF2B5EF4-FFF2-40B4-BE49-F238E27FC236}">
                <a16:creationId xmlns:a16="http://schemas.microsoft.com/office/drawing/2014/main" id="{6C66FDA2-E512-44BA-B4AC-29172E1E3A9B}"/>
              </a:ext>
            </a:extLst>
          </p:cNvPr>
          <p:cNvSpPr txBox="1"/>
          <p:nvPr/>
        </p:nvSpPr>
        <p:spPr>
          <a:xfrm>
            <a:off x="1823953" y="1026367"/>
            <a:ext cx="26080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b="1" dirty="0"/>
              <a:t>e) GSE12814 GEO </a:t>
            </a:r>
            <a:r>
              <a:rPr lang="es-ES_tradnl" b="1" dirty="0" err="1"/>
              <a:t>dataset</a:t>
            </a:r>
            <a:endParaRPr lang="es-ES_tradnl" b="1" dirty="0"/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9A524518-BEF5-4D0A-A52D-276C3B94F293}"/>
              </a:ext>
            </a:extLst>
          </p:cNvPr>
          <p:cNvSpPr txBox="1"/>
          <p:nvPr/>
        </p:nvSpPr>
        <p:spPr>
          <a:xfrm>
            <a:off x="4888164" y="370277"/>
            <a:ext cx="233660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2000" b="1" dirty="0" err="1"/>
              <a:t>Uterine</a:t>
            </a:r>
            <a:r>
              <a:rPr lang="es-ES_tradnl" sz="2000" b="1" dirty="0"/>
              <a:t> </a:t>
            </a:r>
            <a:r>
              <a:rPr lang="es-ES_tradnl" sz="2000" b="1" dirty="0" err="1"/>
              <a:t>leiomyomas</a:t>
            </a:r>
            <a:endParaRPr lang="es-ES_tradnl" sz="2000" b="1" dirty="0"/>
          </a:p>
        </p:txBody>
      </p:sp>
      <p:pic>
        <p:nvPicPr>
          <p:cNvPr id="3" name="Imagen 2">
            <a:extLst>
              <a:ext uri="{FF2B5EF4-FFF2-40B4-BE49-F238E27FC236}">
                <a16:creationId xmlns:a16="http://schemas.microsoft.com/office/drawing/2014/main" id="{8BA65D24-B06F-4E67-ACB7-21F738F5B23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69" y="1469354"/>
            <a:ext cx="6060059" cy="4545045"/>
          </a:xfrm>
          <a:prstGeom prst="rect">
            <a:avLst/>
          </a:prstGeom>
        </p:spPr>
      </p:pic>
      <p:pic>
        <p:nvPicPr>
          <p:cNvPr id="7" name="Imagen 6">
            <a:extLst>
              <a:ext uri="{FF2B5EF4-FFF2-40B4-BE49-F238E27FC236}">
                <a16:creationId xmlns:a16="http://schemas.microsoft.com/office/drawing/2014/main" id="{B1408DC8-E4BB-4F27-ACE5-01D1FA7812A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31096" y="1550868"/>
            <a:ext cx="5608162" cy="467346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CuadroTexto 5">
            <a:extLst>
              <a:ext uri="{FF2B5EF4-FFF2-40B4-BE49-F238E27FC236}">
                <a16:creationId xmlns:a16="http://schemas.microsoft.com/office/drawing/2014/main" id="{00C3B122-484A-45EA-8730-94E004923187}"/>
              </a:ext>
            </a:extLst>
          </p:cNvPr>
          <p:cNvSpPr txBox="1"/>
          <p:nvPr/>
        </p:nvSpPr>
        <p:spPr>
          <a:xfrm>
            <a:off x="86639" y="6270170"/>
            <a:ext cx="1169450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_tradnl" sz="1400" dirty="0"/>
              <a:t>Principal </a:t>
            </a:r>
            <a:r>
              <a:rPr lang="es-ES_tradnl" sz="1400" dirty="0" err="1"/>
              <a:t>Component</a:t>
            </a:r>
            <a:r>
              <a:rPr lang="es-ES_tradnl" sz="1400" dirty="0"/>
              <a:t> </a:t>
            </a:r>
            <a:r>
              <a:rPr lang="es-ES_tradnl" sz="1400" dirty="0" err="1"/>
              <a:t>Analysis</a:t>
            </a:r>
            <a:r>
              <a:rPr lang="es-ES_tradnl" sz="1400" dirty="0"/>
              <a:t> (PCA) </a:t>
            </a:r>
            <a:r>
              <a:rPr lang="en-US" sz="1400" dirty="0"/>
              <a:t>plots of the whole set of genes in the dataset (left) </a:t>
            </a:r>
            <a:r>
              <a:rPr lang="en-US" sz="1400" i="1" dirty="0"/>
              <a:t>vs</a:t>
            </a:r>
            <a:r>
              <a:rPr lang="en-US" sz="1400" dirty="0"/>
              <a:t>. differentially expressed genes after Comparative Analysis of Shapley value analysis (p-value &lt; 0.01) (right).</a:t>
            </a:r>
            <a:r>
              <a:rPr lang="es-ES_tradnl" sz="1400" dirty="0"/>
              <a:t> </a:t>
            </a:r>
          </a:p>
        </p:txBody>
      </p:sp>
      <p:sp>
        <p:nvSpPr>
          <p:cNvPr id="9" name="Rectángulo 8">
            <a:extLst>
              <a:ext uri="{FF2B5EF4-FFF2-40B4-BE49-F238E27FC236}">
                <a16:creationId xmlns:a16="http://schemas.microsoft.com/office/drawing/2014/main" id="{BB154579-13AA-42BF-B6BF-3883E7273093}"/>
              </a:ext>
            </a:extLst>
          </p:cNvPr>
          <p:cNvSpPr/>
          <p:nvPr/>
        </p:nvSpPr>
        <p:spPr>
          <a:xfrm>
            <a:off x="2464232" y="1462009"/>
            <a:ext cx="1090047" cy="24454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364179123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uadroTexto 7">
            <a:extLst>
              <a:ext uri="{FF2B5EF4-FFF2-40B4-BE49-F238E27FC236}">
                <a16:creationId xmlns:a16="http://schemas.microsoft.com/office/drawing/2014/main" id="{6C66FDA2-E512-44BA-B4AC-29172E1E3A9B}"/>
              </a:ext>
            </a:extLst>
          </p:cNvPr>
          <p:cNvSpPr txBox="1"/>
          <p:nvPr/>
        </p:nvSpPr>
        <p:spPr>
          <a:xfrm>
            <a:off x="1823953" y="1026367"/>
            <a:ext cx="25698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b="1" dirty="0"/>
              <a:t>f) GSE23112 GEO </a:t>
            </a:r>
            <a:r>
              <a:rPr lang="es-ES_tradnl" b="1" dirty="0" err="1"/>
              <a:t>dataset</a:t>
            </a:r>
            <a:endParaRPr lang="es-ES_tradnl" b="1" dirty="0"/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9A524518-BEF5-4D0A-A52D-276C3B94F293}"/>
              </a:ext>
            </a:extLst>
          </p:cNvPr>
          <p:cNvSpPr txBox="1"/>
          <p:nvPr/>
        </p:nvSpPr>
        <p:spPr>
          <a:xfrm>
            <a:off x="4888164" y="370277"/>
            <a:ext cx="233660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2000" b="1" dirty="0" err="1"/>
              <a:t>Uterine</a:t>
            </a:r>
            <a:r>
              <a:rPr lang="es-ES_tradnl" sz="2000" b="1" dirty="0"/>
              <a:t> </a:t>
            </a:r>
            <a:r>
              <a:rPr lang="es-ES_tradnl" sz="2000" b="1" dirty="0" err="1"/>
              <a:t>leiomyomas</a:t>
            </a:r>
            <a:endParaRPr lang="es-ES_tradnl" sz="2000" b="1" dirty="0"/>
          </a:p>
        </p:txBody>
      </p:sp>
      <p:pic>
        <p:nvPicPr>
          <p:cNvPr id="6" name="Imagen 5">
            <a:extLst>
              <a:ext uri="{FF2B5EF4-FFF2-40B4-BE49-F238E27FC236}">
                <a16:creationId xmlns:a16="http://schemas.microsoft.com/office/drawing/2014/main" id="{CF3B1493-55A4-4459-A3AB-FC5853EFC0F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765" y="1427082"/>
            <a:ext cx="6060059" cy="4545044"/>
          </a:xfrm>
          <a:prstGeom prst="rect">
            <a:avLst/>
          </a:prstGeom>
        </p:spPr>
      </p:pic>
      <p:pic>
        <p:nvPicPr>
          <p:cNvPr id="7" name="Imagen 6">
            <a:extLst>
              <a:ext uri="{FF2B5EF4-FFF2-40B4-BE49-F238E27FC236}">
                <a16:creationId xmlns:a16="http://schemas.microsoft.com/office/drawing/2014/main" id="{ABDCC483-52B0-4C68-AE10-EDF9AE610DD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04348" y="1512229"/>
            <a:ext cx="5677716" cy="473143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CuadroTexto 8">
            <a:extLst>
              <a:ext uri="{FF2B5EF4-FFF2-40B4-BE49-F238E27FC236}">
                <a16:creationId xmlns:a16="http://schemas.microsoft.com/office/drawing/2014/main" id="{EEEA5CEE-79E7-4731-ACA3-A501625E7F28}"/>
              </a:ext>
            </a:extLst>
          </p:cNvPr>
          <p:cNvSpPr txBox="1"/>
          <p:nvPr/>
        </p:nvSpPr>
        <p:spPr>
          <a:xfrm>
            <a:off x="86639" y="6270170"/>
            <a:ext cx="1169450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_tradnl" sz="1400" dirty="0"/>
              <a:t>Principal </a:t>
            </a:r>
            <a:r>
              <a:rPr lang="es-ES_tradnl" sz="1400" dirty="0" err="1"/>
              <a:t>Component</a:t>
            </a:r>
            <a:r>
              <a:rPr lang="es-ES_tradnl" sz="1400" dirty="0"/>
              <a:t> </a:t>
            </a:r>
            <a:r>
              <a:rPr lang="es-ES_tradnl" sz="1400" dirty="0" err="1"/>
              <a:t>Analysis</a:t>
            </a:r>
            <a:r>
              <a:rPr lang="es-ES_tradnl" sz="1400" dirty="0"/>
              <a:t> (PCA) </a:t>
            </a:r>
            <a:r>
              <a:rPr lang="en-US" sz="1400" dirty="0"/>
              <a:t>plots of the whole set of genes in the dataset (left) </a:t>
            </a:r>
            <a:r>
              <a:rPr lang="en-US" sz="1400" i="1" dirty="0"/>
              <a:t>vs</a:t>
            </a:r>
            <a:r>
              <a:rPr lang="en-US" sz="1400" dirty="0"/>
              <a:t>. differentially expressed genes after Comparative Analysis of Shapley value analysis (p-value &lt; 0.01) (right).</a:t>
            </a:r>
            <a:r>
              <a:rPr lang="es-ES_tradnl" sz="1400" dirty="0"/>
              <a:t> </a:t>
            </a:r>
          </a:p>
        </p:txBody>
      </p:sp>
      <p:sp>
        <p:nvSpPr>
          <p:cNvPr id="10" name="Rectángulo 9">
            <a:extLst>
              <a:ext uri="{FF2B5EF4-FFF2-40B4-BE49-F238E27FC236}">
                <a16:creationId xmlns:a16="http://schemas.microsoft.com/office/drawing/2014/main" id="{B2D0436E-37CB-4681-AE8C-1C34C2A2A674}"/>
              </a:ext>
            </a:extLst>
          </p:cNvPr>
          <p:cNvSpPr/>
          <p:nvPr/>
        </p:nvSpPr>
        <p:spPr>
          <a:xfrm>
            <a:off x="2510726" y="1462009"/>
            <a:ext cx="1090047" cy="24454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0454950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</TotalTime>
  <Words>276</Words>
  <Application>Microsoft Office PowerPoint</Application>
  <PresentationFormat>Panorámica</PresentationFormat>
  <Paragraphs>20</Paragraphs>
  <Slides>6</Slides>
  <Notes>2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Windows User</dc:creator>
  <cp:lastModifiedBy>Windows User</cp:lastModifiedBy>
  <cp:revision>16</cp:revision>
  <dcterms:created xsi:type="dcterms:W3CDTF">2024-05-16T14:56:22Z</dcterms:created>
  <dcterms:modified xsi:type="dcterms:W3CDTF">2024-05-20T19:33:55Z</dcterms:modified>
</cp:coreProperties>
</file>